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14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n-share-02\CAN-Proteomic$\Home\WardDG\Bladder%202015\MISEQ%20PROJECT\RE-ANALYSIS%2017-9-15\read%20count%20gra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>
        <c:manualLayout>
          <c:layoutTarget val="inner"/>
          <c:xMode val="edge"/>
          <c:yMode val="edge"/>
          <c:x val="0.11045968725740268"/>
          <c:y val="5.5621829654712851E-2"/>
          <c:w val="0.88954031274259726"/>
          <c:h val="0.875115118382223"/>
        </c:manualLayout>
      </c:layout>
      <c:barChart>
        <c:barDir val="col"/>
        <c:grouping val="clustered"/>
        <c:ser>
          <c:idx val="0"/>
          <c:order val="0"/>
          <c:errBars>
            <c:errBarType val="both"/>
            <c:errValType val="cust"/>
            <c:noEndCap val="1"/>
            <c:plus>
              <c:numRef>
                <c:f>Sheet1!$I$3:$I$11</c:f>
                <c:numCache>
                  <c:formatCode>General</c:formatCode>
                  <c:ptCount val="9"/>
                  <c:pt idx="0">
                    <c:v>560.72264631760027</c:v>
                  </c:pt>
                  <c:pt idx="1">
                    <c:v>600.54598046702347</c:v>
                  </c:pt>
                  <c:pt idx="2">
                    <c:v>741.8989177944236</c:v>
                  </c:pt>
                  <c:pt idx="3">
                    <c:v>574.53499530733018</c:v>
                  </c:pt>
                  <c:pt idx="4">
                    <c:v>468.49226554784832</c:v>
                  </c:pt>
                  <c:pt idx="5">
                    <c:v>608.82893242104296</c:v>
                  </c:pt>
                  <c:pt idx="6">
                    <c:v>541.86631071390775</c:v>
                  </c:pt>
                  <c:pt idx="7">
                    <c:v>321.57596325990079</c:v>
                  </c:pt>
                  <c:pt idx="8">
                    <c:v>17.947697639395848</c:v>
                  </c:pt>
                </c:numCache>
              </c:numRef>
            </c:plus>
            <c:minus>
              <c:numRef>
                <c:f>Sheet1!$I$3:$I$11</c:f>
                <c:numCache>
                  <c:formatCode>General</c:formatCode>
                  <c:ptCount val="9"/>
                  <c:pt idx="0">
                    <c:v>560.72264631760027</c:v>
                  </c:pt>
                  <c:pt idx="1">
                    <c:v>600.54598046702347</c:v>
                  </c:pt>
                  <c:pt idx="2">
                    <c:v>741.8989177944236</c:v>
                  </c:pt>
                  <c:pt idx="3">
                    <c:v>574.53499530733018</c:v>
                  </c:pt>
                  <c:pt idx="4">
                    <c:v>468.49226554784832</c:v>
                  </c:pt>
                  <c:pt idx="5">
                    <c:v>608.82893242104296</c:v>
                  </c:pt>
                  <c:pt idx="6">
                    <c:v>541.86631071390775</c:v>
                  </c:pt>
                  <c:pt idx="7">
                    <c:v>321.57596325990079</c:v>
                  </c:pt>
                  <c:pt idx="8">
                    <c:v>17.947697639395848</c:v>
                  </c:pt>
                </c:numCache>
              </c:numRef>
            </c:minus>
          </c:errBars>
          <c:val>
            <c:numRef>
              <c:f>Sheet1!$G$4:$G$11</c:f>
              <c:numCache>
                <c:formatCode>General</c:formatCode>
                <c:ptCount val="8"/>
                <c:pt idx="0">
                  <c:v>4502.854166666667</c:v>
                </c:pt>
                <c:pt idx="1">
                  <c:v>4792.8625000000002</c:v>
                </c:pt>
                <c:pt idx="2">
                  <c:v>5155.8571428571431</c:v>
                </c:pt>
                <c:pt idx="3">
                  <c:v>4848.1071428571431</c:v>
                </c:pt>
                <c:pt idx="4">
                  <c:v>5986.7319078947367</c:v>
                </c:pt>
                <c:pt idx="5">
                  <c:v>6238.6369485294117</c:v>
                </c:pt>
                <c:pt idx="6">
                  <c:v>7103.8732638888887</c:v>
                </c:pt>
                <c:pt idx="7">
                  <c:v>159.86677631578948</c:v>
                </c:pt>
              </c:numCache>
            </c:numRef>
          </c:val>
        </c:ser>
        <c:axId val="29938048"/>
        <c:axId val="29939584"/>
      </c:barChart>
      <c:catAx>
        <c:axId val="29938048"/>
        <c:scaling>
          <c:orientation val="minMax"/>
        </c:scaling>
        <c:axPos val="b"/>
        <c:tickLblPos val="nextTo"/>
        <c:crossAx val="29939584"/>
        <c:crosses val="autoZero"/>
        <c:auto val="1"/>
        <c:lblAlgn val="ctr"/>
        <c:lblOffset val="100"/>
      </c:catAx>
      <c:valAx>
        <c:axId val="29939584"/>
        <c:scaling>
          <c:orientation val="minMax"/>
          <c:min val="0"/>
        </c:scaling>
        <c:axPos val="l"/>
        <c:numFmt formatCode="General" sourceLinked="1"/>
        <c:tickLblPos val="nextTo"/>
        <c:crossAx val="29938048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E9554-6F9B-4B1B-B699-150E9C075564}" type="datetimeFigureOut">
              <a:rPr lang="en-GB" smtClean="0"/>
              <a:t>1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B7398-0B2A-4618-B335-A9DFC56E7C6D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76872" y="251520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ure 1.</a:t>
            </a:r>
            <a:endParaRPr lang="en-GB" dirty="0"/>
          </a:p>
        </p:txBody>
      </p:sp>
      <p:grpSp>
        <p:nvGrpSpPr>
          <p:cNvPr id="14" name="Group 13"/>
          <p:cNvGrpSpPr/>
          <p:nvPr/>
        </p:nvGrpSpPr>
        <p:grpSpPr>
          <a:xfrm>
            <a:off x="404664" y="2915816"/>
            <a:ext cx="6192688" cy="4367636"/>
            <a:chOff x="404664" y="4283968"/>
            <a:chExt cx="6192688" cy="4367636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-319316" y="6016060"/>
              <a:ext cx="18172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Mean read depth</a:t>
              </a:r>
              <a:endParaRPr lang="en-GB" dirty="0"/>
            </a:p>
          </p:txBody>
        </p:sp>
        <p:graphicFrame>
          <p:nvGraphicFramePr>
            <p:cNvPr id="7" name="Chart 6"/>
            <p:cNvGraphicFramePr/>
            <p:nvPr/>
          </p:nvGraphicFramePr>
          <p:xfrm>
            <a:off x="476672" y="4283968"/>
            <a:ext cx="6120680" cy="36766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 rot="16200000">
              <a:off x="3383408" y="5472208"/>
              <a:ext cx="838691" cy="55201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GB" dirty="0" smtClean="0"/>
                <a:t>&gt;0.1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0.1-0.2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0.2-0.5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0.5-1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1-5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5-20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&gt;20</a:t>
              </a:r>
            </a:p>
            <a:p>
              <a:pPr algn="r">
                <a:lnSpc>
                  <a:spcPct val="250000"/>
                </a:lnSpc>
              </a:pPr>
              <a:r>
                <a:rPr lang="en-GB" dirty="0" smtClean="0"/>
                <a:t>Blank</a:t>
              </a:r>
              <a:endParaRPr lang="en-GB" dirty="0"/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28800" y="1331640"/>
            <a:ext cx="3948113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1556792" y="827584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1a.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2420888" y="2411760"/>
            <a:ext cx="2999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0    0.5    1      2        5    10    50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445224" y="2411760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n</a:t>
            </a:r>
            <a:r>
              <a:rPr lang="en-GB" dirty="0" err="1" smtClean="0"/>
              <a:t>g</a:t>
            </a:r>
            <a:r>
              <a:rPr lang="en-GB" dirty="0" smtClean="0"/>
              <a:t> DNA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908720" y="1259632"/>
            <a:ext cx="688009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400 </a:t>
            </a:r>
            <a:r>
              <a:rPr lang="en-GB" sz="1400" dirty="0" err="1" smtClean="0"/>
              <a:t>bp</a:t>
            </a:r>
            <a:endParaRPr lang="en-GB" sz="1400" dirty="0" smtClean="0"/>
          </a:p>
          <a:p>
            <a:r>
              <a:rPr lang="en-GB" sz="1400" dirty="0" smtClean="0"/>
              <a:t>300 </a:t>
            </a:r>
            <a:r>
              <a:rPr lang="en-GB" sz="1400" dirty="0" err="1" smtClean="0"/>
              <a:t>bp</a:t>
            </a:r>
            <a:endParaRPr lang="en-GB" sz="1400" dirty="0" smtClean="0"/>
          </a:p>
          <a:p>
            <a:r>
              <a:rPr lang="en-GB" sz="1400" dirty="0" smtClean="0"/>
              <a:t>200 </a:t>
            </a:r>
            <a:r>
              <a:rPr lang="en-GB" sz="1400" dirty="0" err="1" smtClean="0"/>
              <a:t>bp</a:t>
            </a:r>
            <a:endParaRPr lang="en-GB" sz="1400" dirty="0" smtClean="0"/>
          </a:p>
          <a:p>
            <a:r>
              <a:rPr lang="en-GB" sz="1400" dirty="0" smtClean="0"/>
              <a:t>100 </a:t>
            </a:r>
            <a:r>
              <a:rPr lang="en-GB" sz="1400" dirty="0" err="1" smtClean="0"/>
              <a:t>bp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1628800" y="2987824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1b.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260648" y="7380312"/>
            <a:ext cx="659735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itchFamily="34" charset="0"/>
                <a:cs typeface="Arial" pitchFamily="34" charset="0"/>
              </a:rPr>
              <a:t>Figure S1a shows an 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agarose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 gel of the TERT 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promotor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amplicon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 generated using increasing quantities of template DNA.</a:t>
            </a:r>
          </a:p>
          <a:p>
            <a:endParaRPr lang="en-GB" sz="1400" dirty="0">
              <a:latin typeface="Arial" pitchFamily="34" charset="0"/>
              <a:cs typeface="Arial" pitchFamily="34" charset="0"/>
            </a:endParaRPr>
          </a:p>
          <a:p>
            <a:r>
              <a:rPr lang="en-GB" sz="1400" dirty="0" smtClean="0">
                <a:latin typeface="Arial" pitchFamily="34" charset="0"/>
                <a:cs typeface="Arial" pitchFamily="34" charset="0"/>
              </a:rPr>
              <a:t>Figure S1b shows the relationship between read depth and urinary DNA concentration.  Data shown as mean ± SEM .  Units of concentration = 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ul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.  </a:t>
            </a:r>
            <a:endParaRPr lang="en-GB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83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Birmingha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rddg</dc:creator>
  <cp:lastModifiedBy>warddg</cp:lastModifiedBy>
  <cp:revision>6</cp:revision>
  <dcterms:created xsi:type="dcterms:W3CDTF">2015-09-18T11:12:17Z</dcterms:created>
  <dcterms:modified xsi:type="dcterms:W3CDTF">2015-09-18T11:51:28Z</dcterms:modified>
</cp:coreProperties>
</file>